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B3AFF-EFDA-4DFD-94FB-D4C513263D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6E13E-EDC4-4F1B-8A96-BD8E868B2D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A8E40-CF53-4D0D-BB71-25209B993C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63AF8F-5581-4BA9-9F23-A649DB56F0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D97C4-3369-41A6-8FC6-CDF31161DE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F9947-C93A-4F30-984F-D4E078FD37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70E2E-2267-454C-9789-0189B57531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C291D-02FC-48D4-BF96-1C06050F62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BE8D2-206C-4DDC-A2E3-3F223ECB4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77FAB-927A-4B3A-9081-03EEFFFD38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AAF63-9205-4BCE-906B-961D0CF022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7C7F8-6FBD-44C5-90EB-61237FBEA2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730C249-B00B-4966-BB96-326F8675B6BD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414360" y="522360"/>
            <a:ext cx="98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矩形 2"/>
          <p:cNvSpPr/>
          <p:nvPr/>
        </p:nvSpPr>
        <p:spPr>
          <a:xfrm>
            <a:off x="157320" y="4003560"/>
            <a:ext cx="64213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 The proportion of the necrotic area on the whole sample area. (b) Western blotting analysis of lysates from the tumor tissues showing RIP3 and β-actin level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组合 3"/>
          <p:cNvGrpSpPr/>
          <p:nvPr/>
        </p:nvGrpSpPr>
        <p:grpSpPr>
          <a:xfrm>
            <a:off x="2905200" y="1601640"/>
            <a:ext cx="3628800" cy="1562400"/>
            <a:chOff x="2905200" y="1601640"/>
            <a:chExt cx="3628800" cy="1562400"/>
          </a:xfrm>
        </p:grpSpPr>
        <p:sp>
          <p:nvSpPr>
            <p:cNvPr id="44" name="TextBox 4"/>
            <p:cNvSpPr/>
            <p:nvPr/>
          </p:nvSpPr>
          <p:spPr>
            <a:xfrm>
              <a:off x="3294000" y="1601640"/>
              <a:ext cx="618840" cy="33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45" name="Picture 2" descr="C:\Users\yck\Desktop\Sp1-CDDis-Revision\Tumor model-actin.jpg"/>
            <p:cNvPicPr/>
            <p:nvPr/>
          </p:nvPicPr>
          <p:blipFill>
            <a:blip r:embed="rId1"/>
            <a:stretch/>
          </p:blipFill>
          <p:spPr>
            <a:xfrm>
              <a:off x="3834360" y="2754360"/>
              <a:ext cx="2699640" cy="409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3" descr="C:\Users\yck\Desktop\Sp1-CDDis-Revision\Tumor model-RIP3-2.jpg"/>
            <p:cNvPicPr/>
            <p:nvPr/>
          </p:nvPicPr>
          <p:blipFill>
            <a:blip r:embed="rId2"/>
            <a:stretch/>
          </p:blipFill>
          <p:spPr>
            <a:xfrm>
              <a:off x="3834360" y="2223720"/>
              <a:ext cx="2699640" cy="46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7"/>
            <p:cNvSpPr/>
            <p:nvPr/>
          </p:nvSpPr>
          <p:spPr>
            <a:xfrm>
              <a:off x="2998080" y="2250360"/>
              <a:ext cx="87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Exo-RI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3151080" y="2826720"/>
              <a:ext cx="72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9"/>
            <p:cNvSpPr/>
            <p:nvPr/>
          </p:nvSpPr>
          <p:spPr>
            <a:xfrm>
              <a:off x="2905200" y="2403000"/>
              <a:ext cx="1037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 Unicode MS"/>
                </a:rPr>
                <a:t>Endo-RI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直接连接符 10"/>
            <p:cNvSpPr/>
            <p:nvPr/>
          </p:nvSpPr>
          <p:spPr>
            <a:xfrm>
              <a:off x="3943080" y="2151720"/>
              <a:ext cx="1078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直接连接符 11"/>
            <p:cNvSpPr/>
            <p:nvPr/>
          </p:nvSpPr>
          <p:spPr>
            <a:xfrm>
              <a:off x="5311080" y="2151720"/>
              <a:ext cx="1078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2"/>
            <p:cNvSpPr/>
            <p:nvPr/>
          </p:nvSpPr>
          <p:spPr>
            <a:xfrm>
              <a:off x="3942000" y="1863720"/>
              <a:ext cx="1093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L/2-Vecto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3"/>
            <p:cNvSpPr/>
            <p:nvPr/>
          </p:nvSpPr>
          <p:spPr>
            <a:xfrm>
              <a:off x="5440680" y="1863720"/>
              <a:ext cx="1093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LL/2-RIP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4" name="图片 14" descr="C:\Users\yck\Desktop\necrotic area.jpg"/>
          <p:cNvPicPr/>
          <p:nvPr/>
        </p:nvPicPr>
        <p:blipFill>
          <a:blip r:embed="rId3"/>
          <a:stretch/>
        </p:blipFill>
        <p:spPr>
          <a:xfrm>
            <a:off x="169920" y="1495440"/>
            <a:ext cx="2685960" cy="2355840"/>
          </a:xfrm>
          <a:prstGeom prst="rect">
            <a:avLst/>
          </a:prstGeom>
          <a:ln w="0">
            <a:noFill/>
          </a:ln>
        </p:spPr>
      </p:pic>
      <p:sp>
        <p:nvSpPr>
          <p:cNvPr id="55" name="TextBox 15"/>
          <p:cNvSpPr/>
          <p:nvPr/>
        </p:nvSpPr>
        <p:spPr>
          <a:xfrm>
            <a:off x="189000" y="115092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6"/>
          <p:cNvSpPr/>
          <p:nvPr/>
        </p:nvSpPr>
        <p:spPr>
          <a:xfrm>
            <a:off x="3067200" y="1150920"/>
            <a:ext cx="40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2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5:38Z</dcterms:modified>
  <cp:revision>423</cp:revision>
  <dc:subject/>
  <dc:title>幻灯片 1</dc:title>
</cp:coreProperties>
</file>